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14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C0B4790-A5FB-1A18-E8A9-A7E4FE1E41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BF5B97D2-EDEB-A126-51A8-F750CB3DBE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02CB0E9-0E6E-8DBA-1C2B-600B46092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80031-6D7F-4BB5-B0B7-1EBC20E2808A}" type="datetimeFigureOut">
              <a:rPr lang="fr-FR" smtClean="0"/>
              <a:t>26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07DB36E-B098-B15D-7520-E82E0F365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F78499D-BC91-A535-74EB-CDB7D0157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AE980-DD0E-498F-97B8-FDA1A6610B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6278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3DD593E-EC36-B355-4191-6A068E8CC4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6B05C8E-3C58-A9A3-7D08-0DDD2DBA46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9ABB64E-9BDA-DDF7-C9A0-F07AD6CF2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80031-6D7F-4BB5-B0B7-1EBC20E2808A}" type="datetimeFigureOut">
              <a:rPr lang="fr-FR" smtClean="0"/>
              <a:t>26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6A0D9F6-AC7E-02E3-DF9E-DB0A0C92C8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083581C-BBC5-BC96-BEDF-519423650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AE980-DD0E-498F-97B8-FDA1A6610B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7462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566BB13-BFA1-64E2-C4D3-F777C70901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1B5B0A2-8B31-35E2-921D-3BA49FE17C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6BF87ED-4788-EEAD-B01A-75CD9EBD4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80031-6D7F-4BB5-B0B7-1EBC20E2808A}" type="datetimeFigureOut">
              <a:rPr lang="fr-FR" smtClean="0"/>
              <a:t>26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E21B091-95D6-DD3C-B325-4AF94CA030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0B622A3-CF58-A147-D043-C34D412B8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AE980-DD0E-498F-97B8-FDA1A6610B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6641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564483-D07A-194B-8675-244BA4CC14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A0F69EC-13B3-4E08-7B79-64263A2495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B50589-085A-D582-7361-83CE2F62B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80031-6D7F-4BB5-B0B7-1EBC20E2808A}" type="datetimeFigureOut">
              <a:rPr lang="fr-FR" smtClean="0"/>
              <a:t>26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92B9584-7CFF-2A52-E134-191C8FC6F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CA9DB49-A5F5-2215-7BC9-393FB53EA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AE980-DD0E-498F-97B8-FDA1A6610B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96864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E998F98-4505-F643-40F2-A52558BB20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A30F0B6-B410-2FBC-CE89-9307FC3247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EB5EC90-501C-C430-2467-7406D3ABCF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80031-6D7F-4BB5-B0B7-1EBC20E2808A}" type="datetimeFigureOut">
              <a:rPr lang="fr-FR" smtClean="0"/>
              <a:t>26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6C0D73C-B490-ED16-DCCA-87C60ABCC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B4A3B9B-900E-0B3C-E45A-37E405159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AE980-DD0E-498F-97B8-FDA1A6610B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7232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CED006-99BA-94C3-3EDA-4BEA945E6E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88BA02D-4B96-AA96-1CFF-56B9C8914B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D491DFD-1422-151B-B5B5-BB5F4D9393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7BB99E4-522E-A3C4-76ED-B71B06BF22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80031-6D7F-4BB5-B0B7-1EBC20E2808A}" type="datetimeFigureOut">
              <a:rPr lang="fr-FR" smtClean="0"/>
              <a:t>26/03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C855EA9-53B2-F89A-030C-CCC03C8A54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5C8FA98-7857-D46F-D1EA-8F61AB5A3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AE980-DD0E-498F-97B8-FDA1A6610B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5824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9D2C2F4-B944-D8E3-49B5-B6D2379732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9B78B15-BD82-EFEA-DD10-A51D7D35E4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4DA99B9-718B-12E3-6B21-2F4B8B5F51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190AD8ED-E4F3-8DF2-E465-284493FAE0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CB0C2CA-7E9A-C536-7CFC-2027D11F3C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E3281BA6-7655-D188-7F0E-B6A974D849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80031-6D7F-4BB5-B0B7-1EBC20E2808A}" type="datetimeFigureOut">
              <a:rPr lang="fr-FR" smtClean="0"/>
              <a:t>26/03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B18D5BD0-83DF-E452-611B-08D84B74E9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D553831-86EC-A713-04E9-53053A2870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AE980-DD0E-498F-97B8-FDA1A6610B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565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651E0B8-A38C-F13B-6142-BC5034A36E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272FDFF6-1EAA-8465-3FD0-FF6BB1A635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80031-6D7F-4BB5-B0B7-1EBC20E2808A}" type="datetimeFigureOut">
              <a:rPr lang="fr-FR" smtClean="0"/>
              <a:t>26/03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868704E-9FF3-E9BD-8155-15F6E7969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D44D831-66CF-9102-220B-C96F5FE45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AE980-DD0E-498F-97B8-FDA1A6610B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8468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6B759B3-1C23-B8B8-56AB-5009C9F2B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80031-6D7F-4BB5-B0B7-1EBC20E2808A}" type="datetimeFigureOut">
              <a:rPr lang="fr-FR" smtClean="0"/>
              <a:t>26/03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795A9FD1-3B2F-A148-3839-BE5879BEA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A5654B4B-A34B-BA0A-5A13-26C4461774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AE980-DD0E-498F-97B8-FDA1A6610B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2458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92CD840-D8AA-CB08-8E9C-E3BB4AD1A9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4D5ED19-737A-7F38-5B61-81700CE25D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6C7EDEC-558E-3A11-7F9C-8DFA093F94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C0F6C6C-CE58-331A-9CDC-9EFA8EA60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80031-6D7F-4BB5-B0B7-1EBC20E2808A}" type="datetimeFigureOut">
              <a:rPr lang="fr-FR" smtClean="0"/>
              <a:t>26/03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013A97A-8413-020C-6778-0C393F5912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08E4705-1C51-B2AA-C207-74FCD51ED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AE980-DD0E-498F-97B8-FDA1A6610B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97624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4F472AC-8EC5-7987-28AE-E58034B911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CF1729E-7A8F-7616-D4C8-A4E5CE63BA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E5CD8B2-D037-DA24-EDC5-746443F1E9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A02460E-DDED-6A46-1D6A-AE98EE0982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80031-6D7F-4BB5-B0B7-1EBC20E2808A}" type="datetimeFigureOut">
              <a:rPr lang="fr-FR" smtClean="0"/>
              <a:t>26/03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4EA4C0A-743E-25F9-245F-8ADAC96D8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1D55819-071B-AB56-EC14-AF631E3BE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AE980-DD0E-498F-97B8-FDA1A6610B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850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47F0B851-A465-FF4A-4D65-396E534E0F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2CE7DE2-C64F-0D5F-0197-9831332E50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639A7B3-2D44-8228-DCEA-9559D3F337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B80031-6D7F-4BB5-B0B7-1EBC20E2808A}" type="datetimeFigureOut">
              <a:rPr lang="fr-FR" smtClean="0"/>
              <a:t>26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E77FE6A-8CB2-67AB-4C92-2BAE2F507E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4BA8D89-DF0C-4910-8306-638B32BA15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AE980-DD0E-498F-97B8-FDA1A6610B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92147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3">
            <a:extLst>
              <a:ext uri="{FF2B5EF4-FFF2-40B4-BE49-F238E27FC236}">
                <a16:creationId xmlns:a16="http://schemas.microsoft.com/office/drawing/2014/main" id="{CB05CE92-28A3-BAD9-F5FA-6B8C817DB6B7}"/>
              </a:ext>
            </a:extLst>
          </p:cNvPr>
          <p:cNvGrpSpPr>
            <a:grpSpLocks/>
          </p:cNvGrpSpPr>
          <p:nvPr/>
        </p:nvGrpSpPr>
        <p:grpSpPr bwMode="auto">
          <a:xfrm>
            <a:off x="1865313" y="866451"/>
            <a:ext cx="2795588" cy="4546599"/>
            <a:chOff x="3092" y="840"/>
            <a:chExt cx="1761" cy="2864"/>
          </a:xfrm>
        </p:grpSpPr>
        <p:pic>
          <p:nvPicPr>
            <p:cNvPr id="5" name="Picture 34">
              <a:extLst>
                <a:ext uri="{FF2B5EF4-FFF2-40B4-BE49-F238E27FC236}">
                  <a16:creationId xmlns:a16="http://schemas.microsoft.com/office/drawing/2014/main" id="{EBFAF3C5-D96F-D898-12BF-917F913A09C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lum bright="6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59" t="5388" r="38057" b="7347"/>
            <a:stretch>
              <a:fillRect/>
            </a:stretch>
          </p:blipFill>
          <p:spPr bwMode="auto">
            <a:xfrm>
              <a:off x="3336" y="1765"/>
              <a:ext cx="1517" cy="193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 Box 35">
              <a:extLst>
                <a:ext uri="{FF2B5EF4-FFF2-40B4-BE49-F238E27FC236}">
                  <a16:creationId xmlns:a16="http://schemas.microsoft.com/office/drawing/2014/main" id="{72FC7727-6A1D-3D62-272E-AAED725863C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248" y="1302"/>
              <a:ext cx="840" cy="1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altLang="fr-FR" sz="1100" dirty="0" err="1"/>
                <a:t>urea</a:t>
              </a:r>
              <a:r>
                <a:rPr lang="fr-FR" altLang="fr-FR" sz="1100" dirty="0"/>
                <a:t> 8M</a:t>
              </a:r>
              <a:endParaRPr lang="en-US" altLang="fr-FR" sz="1100" dirty="0"/>
            </a:p>
          </p:txBody>
        </p:sp>
        <p:sp>
          <p:nvSpPr>
            <p:cNvPr id="7" name="Text Box 36">
              <a:extLst>
                <a:ext uri="{FF2B5EF4-FFF2-40B4-BE49-F238E27FC236}">
                  <a16:creationId xmlns:a16="http://schemas.microsoft.com/office/drawing/2014/main" id="{527B5908-6717-C605-BCFB-D7A9759BF40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424" y="1302"/>
              <a:ext cx="840" cy="1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altLang="fr-FR" sz="1100" dirty="0" err="1"/>
                <a:t>urea</a:t>
              </a:r>
              <a:r>
                <a:rPr lang="fr-FR" altLang="fr-FR" sz="1100" dirty="0"/>
                <a:t> 2M</a:t>
              </a:r>
              <a:endParaRPr lang="en-US" altLang="fr-FR" sz="1100" dirty="0"/>
            </a:p>
          </p:txBody>
        </p:sp>
        <p:sp>
          <p:nvSpPr>
            <p:cNvPr id="8" name="Text Box 37">
              <a:extLst>
                <a:ext uri="{FF2B5EF4-FFF2-40B4-BE49-F238E27FC236}">
                  <a16:creationId xmlns:a16="http://schemas.microsoft.com/office/drawing/2014/main" id="{BC7E5A4F-CFE6-6D0C-42DB-07667C2A5FF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669" y="1300"/>
              <a:ext cx="840" cy="1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altLang="fr-FR" sz="1100" dirty="0"/>
                <a:t>Post-sumo </a:t>
              </a:r>
              <a:r>
                <a:rPr lang="fr-FR" altLang="fr-FR" sz="1100" dirty="0" err="1"/>
                <a:t>proease</a:t>
              </a:r>
              <a:endParaRPr lang="en-US" altLang="fr-FR" sz="1100" dirty="0"/>
            </a:p>
          </p:txBody>
        </p:sp>
        <p:sp>
          <p:nvSpPr>
            <p:cNvPr id="9" name="Text Box 38">
              <a:extLst>
                <a:ext uri="{FF2B5EF4-FFF2-40B4-BE49-F238E27FC236}">
                  <a16:creationId xmlns:a16="http://schemas.microsoft.com/office/drawing/2014/main" id="{D71843E2-6808-4403-3ACD-2F55C0DE7F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868" y="1300"/>
              <a:ext cx="840" cy="1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altLang="fr-FR" sz="1100" dirty="0"/>
                <a:t>a</a:t>
              </a:r>
              <a:endParaRPr lang="en-US" altLang="fr-FR" sz="1100" dirty="0"/>
            </a:p>
          </p:txBody>
        </p:sp>
        <p:sp>
          <p:nvSpPr>
            <p:cNvPr id="10" name="Text Box 39">
              <a:extLst>
                <a:ext uri="{FF2B5EF4-FFF2-40B4-BE49-F238E27FC236}">
                  <a16:creationId xmlns:a16="http://schemas.microsoft.com/office/drawing/2014/main" id="{279F103B-AF03-0314-9F48-153EB79DB6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354" y="1601"/>
              <a:ext cx="180" cy="1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altLang="fr-FR" sz="1100" dirty="0"/>
                <a:t>b</a:t>
              </a:r>
              <a:endParaRPr lang="en-US" altLang="fr-FR" sz="1100" dirty="0"/>
            </a:p>
          </p:txBody>
        </p:sp>
        <p:sp>
          <p:nvSpPr>
            <p:cNvPr id="11" name="Text Box 40">
              <a:extLst>
                <a:ext uri="{FF2B5EF4-FFF2-40B4-BE49-F238E27FC236}">
                  <a16:creationId xmlns:a16="http://schemas.microsoft.com/office/drawing/2014/main" id="{35A7E908-6F52-5B1D-60F5-07A37BC4A2C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178" y="1228"/>
              <a:ext cx="941" cy="1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altLang="fr-FR" sz="1100" dirty="0"/>
                <a:t>c</a:t>
              </a:r>
              <a:endParaRPr lang="en-US" altLang="fr-FR" sz="1100" dirty="0"/>
            </a:p>
          </p:txBody>
        </p:sp>
        <p:grpSp>
          <p:nvGrpSpPr>
            <p:cNvPr id="12" name="Group 41">
              <a:extLst>
                <a:ext uri="{FF2B5EF4-FFF2-40B4-BE49-F238E27FC236}">
                  <a16:creationId xmlns:a16="http://schemas.microsoft.com/office/drawing/2014/main" id="{EE5E7204-649A-4E2B-DA0C-ECAE0E29F05D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092" y="2060"/>
              <a:ext cx="316" cy="1387"/>
              <a:chOff x="1942" y="1725"/>
              <a:chExt cx="316" cy="1272"/>
            </a:xfrm>
          </p:grpSpPr>
          <p:sp>
            <p:nvSpPr>
              <p:cNvPr id="13" name="Text Box 42">
                <a:extLst>
                  <a:ext uri="{FF2B5EF4-FFF2-40B4-BE49-F238E27FC236}">
                    <a16:creationId xmlns:a16="http://schemas.microsoft.com/office/drawing/2014/main" id="{487F1B36-F43D-782F-B373-90FCB7CB531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42" y="1725"/>
                <a:ext cx="306" cy="1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altLang="fr-FR" sz="1100"/>
                  <a:t>250</a:t>
                </a:r>
                <a:endParaRPr lang="en-US" altLang="fr-FR" sz="1100"/>
              </a:p>
            </p:txBody>
          </p:sp>
          <p:sp>
            <p:nvSpPr>
              <p:cNvPr id="14" name="Text Box 43">
                <a:extLst>
                  <a:ext uri="{FF2B5EF4-FFF2-40B4-BE49-F238E27FC236}">
                    <a16:creationId xmlns:a16="http://schemas.microsoft.com/office/drawing/2014/main" id="{5A10A0DA-D5FC-E449-8291-A3F04452FC1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52" y="1849"/>
                <a:ext cx="306" cy="1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altLang="fr-FR" sz="1100"/>
                  <a:t>150</a:t>
                </a:r>
                <a:endParaRPr lang="en-US" altLang="fr-FR" sz="1100"/>
              </a:p>
            </p:txBody>
          </p:sp>
          <p:sp>
            <p:nvSpPr>
              <p:cNvPr id="15" name="Text Box 44">
                <a:extLst>
                  <a:ext uri="{FF2B5EF4-FFF2-40B4-BE49-F238E27FC236}">
                    <a16:creationId xmlns:a16="http://schemas.microsoft.com/office/drawing/2014/main" id="{9F73719F-6789-A95A-B339-C74B9EBE0C3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44" y="1966"/>
                <a:ext cx="306" cy="15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altLang="fr-FR" sz="1100"/>
                  <a:t>100</a:t>
                </a:r>
                <a:endParaRPr lang="en-US" altLang="fr-FR" sz="1100"/>
              </a:p>
            </p:txBody>
          </p:sp>
          <p:sp>
            <p:nvSpPr>
              <p:cNvPr id="16" name="Text Box 45">
                <a:extLst>
                  <a:ext uri="{FF2B5EF4-FFF2-40B4-BE49-F238E27FC236}">
                    <a16:creationId xmlns:a16="http://schemas.microsoft.com/office/drawing/2014/main" id="{52E881A7-A2F1-623F-7BD4-BD88B21BD72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96" y="2073"/>
                <a:ext cx="252" cy="1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altLang="fr-FR" sz="1100"/>
                  <a:t>75</a:t>
                </a:r>
                <a:endParaRPr lang="en-US" altLang="fr-FR" sz="1100"/>
              </a:p>
            </p:txBody>
          </p:sp>
          <p:sp>
            <p:nvSpPr>
              <p:cNvPr id="17" name="Text Box 46">
                <a:extLst>
                  <a:ext uri="{FF2B5EF4-FFF2-40B4-BE49-F238E27FC236}">
                    <a16:creationId xmlns:a16="http://schemas.microsoft.com/office/drawing/2014/main" id="{829100EC-F1A3-1F52-1FE5-4F1E9068558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000" y="2215"/>
                <a:ext cx="252" cy="1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altLang="fr-FR" sz="1100"/>
                  <a:t>50</a:t>
                </a:r>
                <a:endParaRPr lang="en-US" altLang="fr-FR" sz="1100"/>
              </a:p>
            </p:txBody>
          </p:sp>
          <p:sp>
            <p:nvSpPr>
              <p:cNvPr id="18" name="Text Box 47">
                <a:extLst>
                  <a:ext uri="{FF2B5EF4-FFF2-40B4-BE49-F238E27FC236}">
                    <a16:creationId xmlns:a16="http://schemas.microsoft.com/office/drawing/2014/main" id="{BC532ED0-CFF3-D1A1-4E6F-3AB4DC1C1E0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98" y="2345"/>
                <a:ext cx="252" cy="1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altLang="fr-FR" sz="1100"/>
                  <a:t>37</a:t>
                </a:r>
                <a:endParaRPr lang="en-US" altLang="fr-FR" sz="1100"/>
              </a:p>
            </p:txBody>
          </p:sp>
          <p:sp>
            <p:nvSpPr>
              <p:cNvPr id="19" name="Text Box 48">
                <a:extLst>
                  <a:ext uri="{FF2B5EF4-FFF2-40B4-BE49-F238E27FC236}">
                    <a16:creationId xmlns:a16="http://schemas.microsoft.com/office/drawing/2014/main" id="{19972CE6-A4E9-0197-6D5C-073B5A67367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002" y="2481"/>
                <a:ext cx="252" cy="1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altLang="fr-FR" sz="1100"/>
                  <a:t>25</a:t>
                </a:r>
                <a:endParaRPr lang="en-US" altLang="fr-FR" sz="1100"/>
              </a:p>
            </p:txBody>
          </p:sp>
          <p:sp>
            <p:nvSpPr>
              <p:cNvPr id="20" name="Text Box 49">
                <a:extLst>
                  <a:ext uri="{FF2B5EF4-FFF2-40B4-BE49-F238E27FC236}">
                    <a16:creationId xmlns:a16="http://schemas.microsoft.com/office/drawing/2014/main" id="{0369147B-A520-1A77-0AC9-038A1C656A1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000" y="2575"/>
                <a:ext cx="252" cy="15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altLang="fr-FR" sz="1100"/>
                  <a:t>20</a:t>
                </a:r>
                <a:endParaRPr lang="en-US" altLang="fr-FR" sz="1100"/>
              </a:p>
            </p:txBody>
          </p:sp>
          <p:sp>
            <p:nvSpPr>
              <p:cNvPr id="21" name="Text Box 50">
                <a:extLst>
                  <a:ext uri="{FF2B5EF4-FFF2-40B4-BE49-F238E27FC236}">
                    <a16:creationId xmlns:a16="http://schemas.microsoft.com/office/drawing/2014/main" id="{9BDD7540-AC16-5FE3-71CB-1ED6EC0ABD1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004" y="2693"/>
                <a:ext cx="252" cy="15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altLang="fr-FR" sz="1100"/>
                  <a:t>15</a:t>
                </a:r>
                <a:endParaRPr lang="en-US" altLang="fr-FR" sz="1100"/>
              </a:p>
            </p:txBody>
          </p:sp>
          <p:sp>
            <p:nvSpPr>
              <p:cNvPr id="22" name="Text Box 51">
                <a:extLst>
                  <a:ext uri="{FF2B5EF4-FFF2-40B4-BE49-F238E27FC236}">
                    <a16:creationId xmlns:a16="http://schemas.microsoft.com/office/drawing/2014/main" id="{F8ABCAE8-EDA1-0F9E-66D1-36DD3AD2997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96" y="2847"/>
                <a:ext cx="252" cy="1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altLang="fr-FR" sz="1100"/>
                  <a:t>10</a:t>
                </a:r>
                <a:endParaRPr lang="en-US" altLang="fr-FR" sz="1100"/>
              </a:p>
            </p:txBody>
          </p:sp>
        </p:grpSp>
      </p:grpSp>
      <p:sp>
        <p:nvSpPr>
          <p:cNvPr id="23" name="Text Box 55">
            <a:extLst>
              <a:ext uri="{FF2B5EF4-FFF2-40B4-BE49-F238E27FC236}">
                <a16:creationId xmlns:a16="http://schemas.microsoft.com/office/drawing/2014/main" id="{C8E3C233-988B-97EA-A5AF-0FB1AB2226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64504" y="4413718"/>
            <a:ext cx="57150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altLang="fr-FR" sz="1000" dirty="0"/>
              <a:t>sumo</a:t>
            </a:r>
            <a:endParaRPr lang="en-US" altLang="fr-FR" sz="1000" dirty="0"/>
          </a:p>
        </p:txBody>
      </p:sp>
      <p:sp>
        <p:nvSpPr>
          <p:cNvPr id="24" name="Line 56">
            <a:extLst>
              <a:ext uri="{FF2B5EF4-FFF2-40B4-BE49-F238E27FC236}">
                <a16:creationId xmlns:a16="http://schemas.microsoft.com/office/drawing/2014/main" id="{2C87C596-9B26-D299-0EBD-53F998F03B1E}"/>
              </a:ext>
            </a:extLst>
          </p:cNvPr>
          <p:cNvSpPr>
            <a:spLocks noChangeShapeType="1"/>
          </p:cNvSpPr>
          <p:nvPr/>
        </p:nvSpPr>
        <p:spPr bwMode="auto">
          <a:xfrm>
            <a:off x="4713289" y="4035665"/>
            <a:ext cx="24923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 type="triangle" w="med" len="med"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25" name="Line 57">
            <a:extLst>
              <a:ext uri="{FF2B5EF4-FFF2-40B4-BE49-F238E27FC236}">
                <a16:creationId xmlns:a16="http://schemas.microsoft.com/office/drawing/2014/main" id="{86DD96B0-EBDD-5720-B3FD-282C2F587E27}"/>
              </a:ext>
            </a:extLst>
          </p:cNvPr>
          <p:cNvSpPr>
            <a:spLocks noChangeShapeType="1"/>
          </p:cNvSpPr>
          <p:nvPr/>
        </p:nvSpPr>
        <p:spPr bwMode="auto">
          <a:xfrm>
            <a:off x="4700589" y="3788015"/>
            <a:ext cx="24923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 type="triangle" w="med" len="med"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26" name="Text Box 58">
            <a:extLst>
              <a:ext uri="{FF2B5EF4-FFF2-40B4-BE49-F238E27FC236}">
                <a16:creationId xmlns:a16="http://schemas.microsoft.com/office/drawing/2014/main" id="{CE73E632-9BD0-E449-A0C8-C210511B66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75226" y="3638790"/>
            <a:ext cx="99060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altLang="fr-FR" sz="1000"/>
              <a:t>Sumo 16 VP</a:t>
            </a:r>
            <a:endParaRPr lang="en-US" altLang="fr-FR" sz="1000"/>
          </a:p>
        </p:txBody>
      </p:sp>
      <p:sp>
        <p:nvSpPr>
          <p:cNvPr id="27" name="Text Box 59">
            <a:extLst>
              <a:ext uri="{FF2B5EF4-FFF2-40B4-BE49-F238E27FC236}">
                <a16:creationId xmlns:a16="http://schemas.microsoft.com/office/drawing/2014/main" id="{FE96E1EE-8736-8621-FE2E-EF2A5C04E1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62526" y="3892790"/>
            <a:ext cx="99060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altLang="fr-FR" sz="1000"/>
              <a:t>16 VP</a:t>
            </a:r>
            <a:endParaRPr lang="en-US" altLang="fr-FR" sz="1000"/>
          </a:p>
        </p:txBody>
      </p:sp>
      <p:pic>
        <p:nvPicPr>
          <p:cNvPr id="1026" name="Image 10">
            <a:extLst>
              <a:ext uri="{FF2B5EF4-FFF2-40B4-BE49-F238E27FC236}">
                <a16:creationId xmlns:a16="http://schemas.microsoft.com/office/drawing/2014/main" id="{B86484CB-761E-4F08-46E0-BCBEB9892AB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24282" y="1801127"/>
            <a:ext cx="2876550" cy="2952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" name="Text Box 35">
            <a:extLst>
              <a:ext uri="{FF2B5EF4-FFF2-40B4-BE49-F238E27FC236}">
                <a16:creationId xmlns:a16="http://schemas.microsoft.com/office/drawing/2014/main" id="{6648ABC4-5B93-3069-80AF-827D0383346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830761" y="1537963"/>
            <a:ext cx="1333500" cy="260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FR" altLang="fr-FR" sz="1100" dirty="0"/>
              <a:t>MW</a:t>
            </a:r>
            <a:endParaRPr lang="en-US" altLang="fr-FR" sz="1100" dirty="0"/>
          </a:p>
        </p:txBody>
      </p:sp>
      <p:sp>
        <p:nvSpPr>
          <p:cNvPr id="29" name="Line 56">
            <a:extLst>
              <a:ext uri="{FF2B5EF4-FFF2-40B4-BE49-F238E27FC236}">
                <a16:creationId xmlns:a16="http://schemas.microsoft.com/office/drawing/2014/main" id="{66260AB1-9C8B-5782-5128-F31202E849C4}"/>
              </a:ext>
            </a:extLst>
          </p:cNvPr>
          <p:cNvSpPr>
            <a:spLocks noChangeShapeType="1"/>
          </p:cNvSpPr>
          <p:nvPr/>
        </p:nvSpPr>
        <p:spPr bwMode="auto">
          <a:xfrm>
            <a:off x="4725989" y="4535956"/>
            <a:ext cx="24923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 type="triangle" w="med" len="med"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F7398F0A-E674-3D9D-FABF-A1413829FBD8}"/>
              </a:ext>
            </a:extLst>
          </p:cNvPr>
          <p:cNvSpPr txBox="1"/>
          <p:nvPr/>
        </p:nvSpPr>
        <p:spPr>
          <a:xfrm>
            <a:off x="2804576" y="739729"/>
            <a:ext cx="12455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Original gel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CAFA339F-4A6E-F1A6-A3E6-3A5B2ADC8BB5}"/>
              </a:ext>
            </a:extLst>
          </p:cNvPr>
          <p:cNvSpPr txBox="1"/>
          <p:nvPr/>
        </p:nvSpPr>
        <p:spPr>
          <a:xfrm>
            <a:off x="7016573" y="543285"/>
            <a:ext cx="345338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. S1e </a:t>
            </a:r>
          </a:p>
          <a:p>
            <a:r>
              <a:rPr lang="fr-FR" dirty="0" err="1"/>
              <a:t>After</a:t>
            </a:r>
            <a:r>
              <a:rPr lang="fr-FR" dirty="0"/>
              <a:t> </a:t>
            </a:r>
            <a:r>
              <a:rPr lang="fr-FR" dirty="0" err="1"/>
              <a:t>removal</a:t>
            </a:r>
            <a:r>
              <a:rPr lang="fr-FR" dirty="0"/>
              <a:t> of 1st </a:t>
            </a:r>
            <a:r>
              <a:rPr lang="fr-FR" dirty="0" err="1"/>
              <a:t>three</a:t>
            </a:r>
            <a:r>
              <a:rPr lang="fr-FR" dirty="0"/>
              <a:t> </a:t>
            </a:r>
            <a:r>
              <a:rPr lang="fr-FR" dirty="0" err="1"/>
              <a:t>column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1333181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7</Words>
  <Application>Microsoft Office PowerPoint</Application>
  <PresentationFormat>Grand écran</PresentationFormat>
  <Paragraphs>2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Sanof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ecouturier, Valerie /FR</dc:creator>
  <cp:lastModifiedBy>Lecouturier, Valerie /FR</cp:lastModifiedBy>
  <cp:revision>1</cp:revision>
  <dcterms:created xsi:type="dcterms:W3CDTF">2024-03-26T13:38:56Z</dcterms:created>
  <dcterms:modified xsi:type="dcterms:W3CDTF">2024-03-26T13:45:51Z</dcterms:modified>
</cp:coreProperties>
</file>